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4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940" autoAdjust="0"/>
    <p:restoredTop sz="94660"/>
  </p:normalViewPr>
  <p:slideViewPr>
    <p:cSldViewPr>
      <p:cViewPr>
        <p:scale>
          <a:sx n="90" d="100"/>
          <a:sy n="90" d="100"/>
        </p:scale>
        <p:origin x="-240" y="-306"/>
      </p:cViewPr>
      <p:guideLst>
        <p:guide orient="horz" pos="2160"/>
        <p:guide pos="24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046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835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082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87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892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826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926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298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1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439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215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7B0E01-003D-455F-8563-995E5F1FCD3B}" type="datetimeFigureOut">
              <a:rPr lang="en-US" smtClean="0"/>
              <a:t>9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C29E0-8E3E-4EC4-B08C-B080E7025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826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1.tiff"/><Relationship Id="rId18" Type="http://schemas.microsoft.com/office/2007/relationships/hdphoto" Target="../media/hdphoto2.wdp"/><Relationship Id="rId3" Type="http://schemas.openxmlformats.org/officeDocument/2006/relationships/image" Target="../media/image2.tiff"/><Relationship Id="rId21" Type="http://schemas.openxmlformats.org/officeDocument/2006/relationships/image" Target="../media/image17.tif"/><Relationship Id="rId7" Type="http://schemas.openxmlformats.org/officeDocument/2006/relationships/image" Target="../media/image6.tiff"/><Relationship Id="rId12" Type="http://schemas.microsoft.com/office/2007/relationships/hdphoto" Target="../media/hdphoto1.wdp"/><Relationship Id="rId17" Type="http://schemas.openxmlformats.org/officeDocument/2006/relationships/image" Target="../media/image15.png"/><Relationship Id="rId2" Type="http://schemas.openxmlformats.org/officeDocument/2006/relationships/image" Target="../media/image1.tiff"/><Relationship Id="rId16" Type="http://schemas.openxmlformats.org/officeDocument/2006/relationships/image" Target="../media/image14.tiff"/><Relationship Id="rId20" Type="http://schemas.microsoft.com/office/2007/relationships/hdphoto" Target="../media/hdphoto3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png"/><Relationship Id="rId24" Type="http://schemas.openxmlformats.org/officeDocument/2006/relationships/image" Target="../media/image20.tiff"/><Relationship Id="rId5" Type="http://schemas.openxmlformats.org/officeDocument/2006/relationships/image" Target="../media/image4.tiff"/><Relationship Id="rId15" Type="http://schemas.openxmlformats.org/officeDocument/2006/relationships/image" Target="../media/image13.tiff"/><Relationship Id="rId23" Type="http://schemas.openxmlformats.org/officeDocument/2006/relationships/image" Target="../media/image19.tiff"/><Relationship Id="rId10" Type="http://schemas.openxmlformats.org/officeDocument/2006/relationships/image" Target="../media/image9.tiff"/><Relationship Id="rId19" Type="http://schemas.openxmlformats.org/officeDocument/2006/relationships/image" Target="../media/image16.png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2.tiff"/><Relationship Id="rId22" Type="http://schemas.openxmlformats.org/officeDocument/2006/relationships/image" Target="../media/image18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tiff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tiff"/><Relationship Id="rId3" Type="http://schemas.openxmlformats.org/officeDocument/2006/relationships/image" Target="../media/image27.tiff"/><Relationship Id="rId7" Type="http://schemas.openxmlformats.org/officeDocument/2006/relationships/image" Target="../media/image31.tiff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tiff"/><Relationship Id="rId5" Type="http://schemas.openxmlformats.org/officeDocument/2006/relationships/image" Target="../media/image29.tiff"/><Relationship Id="rId4" Type="http://schemas.openxmlformats.org/officeDocument/2006/relationships/image" Target="../media/image28.tiff"/><Relationship Id="rId9" Type="http://schemas.openxmlformats.org/officeDocument/2006/relationships/image" Target="../media/image33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openxmlformats.org/officeDocument/2006/relationships/image" Target="../media/image43.tiff"/><Relationship Id="rId3" Type="http://schemas.openxmlformats.org/officeDocument/2006/relationships/image" Target="../media/image35.tiff"/><Relationship Id="rId7" Type="http://schemas.openxmlformats.org/officeDocument/2006/relationships/image" Target="../media/image39.tiff"/><Relationship Id="rId12" Type="http://schemas.microsoft.com/office/2007/relationships/hdphoto" Target="../media/hdphoto5.wdp"/><Relationship Id="rId2" Type="http://schemas.openxmlformats.org/officeDocument/2006/relationships/image" Target="../media/image3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tiff"/><Relationship Id="rId11" Type="http://schemas.openxmlformats.org/officeDocument/2006/relationships/image" Target="../media/image42.png"/><Relationship Id="rId5" Type="http://schemas.openxmlformats.org/officeDocument/2006/relationships/image" Target="../media/image37.tiff"/><Relationship Id="rId15" Type="http://schemas.openxmlformats.org/officeDocument/2006/relationships/image" Target="../media/image45.tiff"/><Relationship Id="rId10" Type="http://schemas.openxmlformats.org/officeDocument/2006/relationships/image" Target="../media/image41.tiff"/><Relationship Id="rId4" Type="http://schemas.openxmlformats.org/officeDocument/2006/relationships/image" Target="../media/image36.tif"/><Relationship Id="rId9" Type="http://schemas.microsoft.com/office/2007/relationships/hdphoto" Target="../media/hdphoto4.wdp"/><Relationship Id="rId14" Type="http://schemas.openxmlformats.org/officeDocument/2006/relationships/image" Target="../media/image44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tiff"/><Relationship Id="rId13" Type="http://schemas.openxmlformats.org/officeDocument/2006/relationships/image" Target="../media/image57.tiff"/><Relationship Id="rId3" Type="http://schemas.openxmlformats.org/officeDocument/2006/relationships/image" Target="../media/image47.tiff"/><Relationship Id="rId7" Type="http://schemas.openxmlformats.org/officeDocument/2006/relationships/image" Target="../media/image51.tiff"/><Relationship Id="rId12" Type="http://schemas.openxmlformats.org/officeDocument/2006/relationships/image" Target="../media/image56.tiff"/><Relationship Id="rId17" Type="http://schemas.openxmlformats.org/officeDocument/2006/relationships/image" Target="../media/image61.tiff"/><Relationship Id="rId2" Type="http://schemas.openxmlformats.org/officeDocument/2006/relationships/image" Target="../media/image46.tiff"/><Relationship Id="rId16" Type="http://schemas.openxmlformats.org/officeDocument/2006/relationships/image" Target="../media/image6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tiff"/><Relationship Id="rId11" Type="http://schemas.openxmlformats.org/officeDocument/2006/relationships/image" Target="../media/image55.tiff"/><Relationship Id="rId5" Type="http://schemas.openxmlformats.org/officeDocument/2006/relationships/image" Target="../media/image49.tiff"/><Relationship Id="rId15" Type="http://schemas.openxmlformats.org/officeDocument/2006/relationships/image" Target="../media/image59.jpeg"/><Relationship Id="rId10" Type="http://schemas.openxmlformats.org/officeDocument/2006/relationships/image" Target="../media/image54.jpeg"/><Relationship Id="rId4" Type="http://schemas.openxmlformats.org/officeDocument/2006/relationships/image" Target="../media/image48.tiff"/><Relationship Id="rId9" Type="http://schemas.openxmlformats.org/officeDocument/2006/relationships/image" Target="../media/image53.tiff"/><Relationship Id="rId14" Type="http://schemas.openxmlformats.org/officeDocument/2006/relationships/image" Target="../media/image5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2399" y="0"/>
            <a:ext cx="81566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: Representative blots to support Figure 5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981200" y="1002268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sta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629400" y="1002268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K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28600" y="1466527"/>
            <a:ext cx="3778540" cy="856590"/>
            <a:chOff x="-14670" y="3818250"/>
            <a:chExt cx="4147808" cy="1276290"/>
          </a:xfrm>
        </p:grpSpPr>
        <p:grpSp>
          <p:nvGrpSpPr>
            <p:cNvPr id="6" name="Group 5"/>
            <p:cNvGrpSpPr/>
            <p:nvPr/>
          </p:nvGrpSpPr>
          <p:grpSpPr>
            <a:xfrm>
              <a:off x="-14670" y="3818252"/>
              <a:ext cx="4147808" cy="1276288"/>
              <a:chOff x="-14670" y="3818252"/>
              <a:chExt cx="4147808" cy="1276288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95" t="25282" r="4139" b="62006"/>
              <a:stretch/>
            </p:blipFill>
            <p:spPr>
              <a:xfrm>
                <a:off x="569782" y="4287564"/>
                <a:ext cx="3563356" cy="367561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-14670" y="4325779"/>
                <a:ext cx="685799" cy="4213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MPK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71" t="28072" r="6563" b="54979"/>
              <a:stretch/>
            </p:blipFill>
            <p:spPr>
              <a:xfrm>
                <a:off x="569782" y="4646394"/>
                <a:ext cx="3563356" cy="367563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-14670" y="4673185"/>
                <a:ext cx="913319" cy="4213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>
                <a:off x="630238" y="4180567"/>
                <a:ext cx="11289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1844064" y="4180567"/>
                <a:ext cx="10972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3026263" y="4180567"/>
                <a:ext cx="10058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1051120" y="3818252"/>
                <a:ext cx="708024" cy="4213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>
              <a:off x="2067042" y="3818250"/>
              <a:ext cx="920937" cy="4213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175171" y="3818252"/>
              <a:ext cx="708024" cy="4213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4794283" y="1502254"/>
            <a:ext cx="3775830" cy="802572"/>
            <a:chOff x="4598148" y="3926145"/>
            <a:chExt cx="4769211" cy="1068553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7220" y="4304640"/>
              <a:ext cx="4100139" cy="34624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50" t="32000" r="22083" b="57334"/>
            <a:stretch/>
          </p:blipFill>
          <p:spPr>
            <a:xfrm>
              <a:off x="5267221" y="4651178"/>
              <a:ext cx="4100138" cy="343520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4603030" y="4307621"/>
              <a:ext cx="736985" cy="3278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MPK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598148" y="4648373"/>
              <a:ext cx="839713" cy="3278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012312" y="3926145"/>
              <a:ext cx="708025" cy="3278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5263434" y="4227023"/>
              <a:ext cx="13859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6689013" y="4227022"/>
              <a:ext cx="127046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7967653" y="4227022"/>
              <a:ext cx="135131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5692775" y="3940015"/>
              <a:ext cx="708025" cy="3278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329539" y="3929171"/>
              <a:ext cx="708025" cy="3278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4766831" y="2424300"/>
            <a:ext cx="3796129" cy="820234"/>
            <a:chOff x="4570707" y="5096987"/>
            <a:chExt cx="4775153" cy="898098"/>
          </a:xfrm>
        </p:grpSpPr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2564" y="5437000"/>
              <a:ext cx="4083296" cy="2842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9892" y="5717181"/>
              <a:ext cx="4083296" cy="277904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>
              <a:off x="4570707" y="5446983"/>
              <a:ext cx="862668" cy="26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MPK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570707" y="5679703"/>
              <a:ext cx="862668" cy="26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689758" y="5096988"/>
              <a:ext cx="708024" cy="26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Straight Connector 33"/>
            <p:cNvCxnSpPr/>
            <p:nvPr/>
          </p:nvCxnSpPr>
          <p:spPr>
            <a:xfrm>
              <a:off x="5259580" y="5393126"/>
              <a:ext cx="1299753" cy="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7009486" y="5096987"/>
              <a:ext cx="708024" cy="2695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Straight Connector 35"/>
            <p:cNvCxnSpPr/>
            <p:nvPr/>
          </p:nvCxnSpPr>
          <p:spPr>
            <a:xfrm>
              <a:off x="6626078" y="5393126"/>
              <a:ext cx="128825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8318393" y="5137928"/>
              <a:ext cx="708024" cy="2695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7960903" y="5393126"/>
              <a:ext cx="13227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7" name="Group 116"/>
          <p:cNvGrpSpPr/>
          <p:nvPr/>
        </p:nvGrpSpPr>
        <p:grpSpPr>
          <a:xfrm>
            <a:off x="203051" y="2460068"/>
            <a:ext cx="3831074" cy="804182"/>
            <a:chOff x="457894" y="2512368"/>
            <a:chExt cx="3322809" cy="697492"/>
          </a:xfrm>
        </p:grpSpPr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95" t="33574" r="2897" b="53513"/>
            <a:stretch/>
          </p:blipFill>
          <p:spPr>
            <a:xfrm>
              <a:off x="941838" y="2738556"/>
              <a:ext cx="2815461" cy="225534"/>
            </a:xfrm>
            <a:prstGeom prst="rect">
              <a:avLst/>
            </a:prstGeom>
          </p:spPr>
        </p:pic>
        <p:sp>
          <p:nvSpPr>
            <p:cNvPr id="41" name="TextBox 40"/>
            <p:cNvSpPr txBox="1"/>
            <p:nvPr/>
          </p:nvSpPr>
          <p:spPr>
            <a:xfrm>
              <a:off x="457894" y="2744041"/>
              <a:ext cx="7051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MPK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778" t="47417" r="1602" b="39669"/>
            <a:stretch/>
          </p:blipFill>
          <p:spPr>
            <a:xfrm>
              <a:off x="941838" y="2962253"/>
              <a:ext cx="2815461" cy="221022"/>
            </a:xfrm>
            <a:prstGeom prst="rect">
              <a:avLst/>
            </a:prstGeom>
          </p:spPr>
        </p:pic>
        <p:sp>
          <p:nvSpPr>
            <p:cNvPr id="43" name="TextBox 42"/>
            <p:cNvSpPr txBox="1"/>
            <p:nvPr/>
          </p:nvSpPr>
          <p:spPr>
            <a:xfrm>
              <a:off x="461061" y="2963639"/>
              <a:ext cx="7020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Straight Connector 43"/>
            <p:cNvCxnSpPr/>
            <p:nvPr/>
          </p:nvCxnSpPr>
          <p:spPr>
            <a:xfrm>
              <a:off x="1008778" y="2702219"/>
              <a:ext cx="8573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1273141" y="2514599"/>
              <a:ext cx="5606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Straight Connector 45"/>
            <p:cNvCxnSpPr/>
            <p:nvPr/>
          </p:nvCxnSpPr>
          <p:spPr>
            <a:xfrm>
              <a:off x="1934047" y="2702219"/>
              <a:ext cx="79641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2066229" y="2512368"/>
              <a:ext cx="7941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Straight Connector 47"/>
            <p:cNvCxnSpPr/>
            <p:nvPr/>
          </p:nvCxnSpPr>
          <p:spPr>
            <a:xfrm>
              <a:off x="2859316" y="2702219"/>
              <a:ext cx="86114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2991497" y="2512369"/>
              <a:ext cx="7892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228600" y="3411377"/>
            <a:ext cx="3792031" cy="853651"/>
            <a:chOff x="304800" y="329412"/>
            <a:chExt cx="4296929" cy="853651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59" t="3392" r="5926" b="79647"/>
            <a:stretch/>
          </p:blipFill>
          <p:spPr>
            <a:xfrm>
              <a:off x="925841" y="900080"/>
              <a:ext cx="3675888" cy="276606"/>
            </a:xfrm>
            <a:prstGeom prst="rect">
              <a:avLst/>
            </a:prstGeom>
          </p:spPr>
        </p:pic>
        <p:cxnSp>
          <p:nvCxnSpPr>
            <p:cNvPr id="52" name="Straight Connector 51"/>
            <p:cNvCxnSpPr/>
            <p:nvPr/>
          </p:nvCxnSpPr>
          <p:spPr>
            <a:xfrm>
              <a:off x="945352" y="550623"/>
              <a:ext cx="118824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304800" y="634215"/>
              <a:ext cx="9812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eNO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05425" y="936842"/>
              <a:ext cx="9812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248155" y="329414"/>
              <a:ext cx="6868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Straight Connector 55"/>
            <p:cNvCxnSpPr/>
            <p:nvPr/>
          </p:nvCxnSpPr>
          <p:spPr>
            <a:xfrm>
              <a:off x="2209800" y="550623"/>
              <a:ext cx="1143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2467355" y="329413"/>
              <a:ext cx="6868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Straight Connector 57"/>
            <p:cNvCxnSpPr/>
            <p:nvPr/>
          </p:nvCxnSpPr>
          <p:spPr>
            <a:xfrm>
              <a:off x="3429000" y="550623"/>
              <a:ext cx="1143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3672287" y="329412"/>
              <a:ext cx="6868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0" name="Picture 59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" contrast="1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5841" y="626823"/>
              <a:ext cx="3675888" cy="273257"/>
            </a:xfrm>
            <a:prstGeom prst="rect">
              <a:avLst/>
            </a:prstGeom>
          </p:spPr>
        </p:pic>
      </p:grpSp>
      <p:grpSp>
        <p:nvGrpSpPr>
          <p:cNvPr id="61" name="Group 60"/>
          <p:cNvGrpSpPr/>
          <p:nvPr/>
        </p:nvGrpSpPr>
        <p:grpSpPr>
          <a:xfrm>
            <a:off x="4794283" y="3354004"/>
            <a:ext cx="3769128" cy="858019"/>
            <a:chOff x="304800" y="3390989"/>
            <a:chExt cx="4231589" cy="858019"/>
          </a:xfrm>
        </p:grpSpPr>
        <p:pic>
          <p:nvPicPr>
            <p:cNvPr id="62" name="Picture 61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1979" y="3700759"/>
              <a:ext cx="3644410" cy="274238"/>
            </a:xfrm>
            <a:prstGeom prst="rect">
              <a:avLst/>
            </a:prstGeom>
          </p:spPr>
        </p:pic>
        <p:pic>
          <p:nvPicPr>
            <p:cNvPr id="63" name="Picture 62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03" t="6085" r="16160" b="74705"/>
            <a:stretch/>
          </p:blipFill>
          <p:spPr>
            <a:xfrm>
              <a:off x="888810" y="3974770"/>
              <a:ext cx="3644410" cy="274238"/>
            </a:xfrm>
            <a:prstGeom prst="rect">
              <a:avLst/>
            </a:prstGeom>
          </p:spPr>
        </p:pic>
        <p:cxnSp>
          <p:nvCxnSpPr>
            <p:cNvPr id="64" name="Straight Connector 63"/>
            <p:cNvCxnSpPr/>
            <p:nvPr/>
          </p:nvCxnSpPr>
          <p:spPr>
            <a:xfrm>
              <a:off x="878043" y="3634018"/>
              <a:ext cx="11752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1219200" y="3395037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04800" y="3703055"/>
              <a:ext cx="76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eNO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04800" y="3977364"/>
              <a:ext cx="76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2142246" y="3632030"/>
              <a:ext cx="1143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2365080" y="3390989"/>
              <a:ext cx="8174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Straight Connector 69"/>
            <p:cNvCxnSpPr/>
            <p:nvPr/>
          </p:nvCxnSpPr>
          <p:spPr>
            <a:xfrm>
              <a:off x="3391675" y="3632030"/>
              <a:ext cx="112925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3525354" y="3403865"/>
              <a:ext cx="81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Group 71"/>
          <p:cNvGrpSpPr/>
          <p:nvPr/>
        </p:nvGrpSpPr>
        <p:grpSpPr>
          <a:xfrm>
            <a:off x="157163" y="4393439"/>
            <a:ext cx="3881439" cy="850205"/>
            <a:chOff x="4803170" y="2786793"/>
            <a:chExt cx="4366327" cy="850205"/>
          </a:xfrm>
        </p:grpSpPr>
        <p:pic>
          <p:nvPicPr>
            <p:cNvPr id="73" name="Picture 72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289" t="67449" r="1603" b="12924"/>
            <a:stretch/>
          </p:blipFill>
          <p:spPr>
            <a:xfrm>
              <a:off x="5486400" y="3092742"/>
              <a:ext cx="3657600" cy="276606"/>
            </a:xfrm>
            <a:prstGeom prst="rect">
              <a:avLst/>
            </a:prstGeom>
          </p:spPr>
        </p:pic>
        <p:sp>
          <p:nvSpPr>
            <p:cNvPr id="74" name="TextBox 73"/>
            <p:cNvSpPr txBox="1"/>
            <p:nvPr/>
          </p:nvSpPr>
          <p:spPr>
            <a:xfrm>
              <a:off x="4849698" y="3116984"/>
              <a:ext cx="8053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GC-1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Straight Connector 74"/>
            <p:cNvCxnSpPr/>
            <p:nvPr/>
          </p:nvCxnSpPr>
          <p:spPr>
            <a:xfrm>
              <a:off x="5486400" y="3016542"/>
              <a:ext cx="1143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6725157" y="3016542"/>
              <a:ext cx="10972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>
              <a:off x="7935593" y="3016542"/>
              <a:ext cx="118994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>
              <a:off x="5616743" y="2795333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6818924" y="2795333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8063582" y="2786793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1" name="Picture 80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215" t="11158" r="7652" b="75182"/>
            <a:stretch/>
          </p:blipFill>
          <p:spPr>
            <a:xfrm>
              <a:off x="5486400" y="3359567"/>
              <a:ext cx="3657600" cy="277431"/>
            </a:xfrm>
            <a:prstGeom prst="rect">
              <a:avLst/>
            </a:prstGeom>
          </p:spPr>
        </p:pic>
        <p:sp>
          <p:nvSpPr>
            <p:cNvPr id="82" name="TextBox 81"/>
            <p:cNvSpPr txBox="1"/>
            <p:nvPr/>
          </p:nvSpPr>
          <p:spPr>
            <a:xfrm>
              <a:off x="4803170" y="3376031"/>
              <a:ext cx="8777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3" name="Group 82"/>
          <p:cNvGrpSpPr/>
          <p:nvPr/>
        </p:nvGrpSpPr>
        <p:grpSpPr>
          <a:xfrm>
            <a:off x="4724400" y="4409166"/>
            <a:ext cx="3850736" cy="866255"/>
            <a:chOff x="4809345" y="4067329"/>
            <a:chExt cx="4312096" cy="866255"/>
          </a:xfrm>
        </p:grpSpPr>
        <p:grpSp>
          <p:nvGrpSpPr>
            <p:cNvPr id="84" name="Group 83"/>
            <p:cNvGrpSpPr/>
            <p:nvPr/>
          </p:nvGrpSpPr>
          <p:grpSpPr>
            <a:xfrm>
              <a:off x="5486399" y="4367177"/>
              <a:ext cx="3635042" cy="545855"/>
              <a:chOff x="5495034" y="2789631"/>
              <a:chExt cx="3635042" cy="545855"/>
            </a:xfrm>
          </p:grpSpPr>
          <p:pic>
            <p:nvPicPr>
              <p:cNvPr id="93" name="Picture 92"/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8630" b="10391"/>
              <a:stretch/>
            </p:blipFill>
            <p:spPr>
              <a:xfrm>
                <a:off x="5495035" y="2789631"/>
                <a:ext cx="3635041" cy="274900"/>
              </a:xfrm>
              <a:prstGeom prst="rect">
                <a:avLst/>
              </a:prstGeom>
            </p:spPr>
          </p:pic>
          <p:pic>
            <p:nvPicPr>
              <p:cNvPr id="94" name="Picture 93"/>
              <p:cNvPicPr>
                <a:picLocks noChangeAspect="1"/>
              </p:cNvPicPr>
              <p:nvPr/>
            </p:nvPicPr>
            <p:blipFill rotWithShape="1"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312" t="5211" r="3068" b="77400"/>
              <a:stretch/>
            </p:blipFill>
            <p:spPr>
              <a:xfrm>
                <a:off x="5495034" y="3060586"/>
                <a:ext cx="3635041" cy="274900"/>
              </a:xfrm>
              <a:prstGeom prst="rect">
                <a:avLst/>
              </a:prstGeom>
            </p:spPr>
          </p:pic>
        </p:grpSp>
        <p:sp>
          <p:nvSpPr>
            <p:cNvPr id="85" name="TextBox 84"/>
            <p:cNvSpPr txBox="1"/>
            <p:nvPr/>
          </p:nvSpPr>
          <p:spPr>
            <a:xfrm>
              <a:off x="4809346" y="4687363"/>
              <a:ext cx="8777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4809345" y="4382563"/>
              <a:ext cx="8060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GC-1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Straight Connector 86"/>
            <p:cNvCxnSpPr/>
            <p:nvPr/>
          </p:nvCxnSpPr>
          <p:spPr>
            <a:xfrm>
              <a:off x="5480668" y="4286324"/>
              <a:ext cx="12110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>
              <a:off x="6777607" y="4286324"/>
              <a:ext cx="10972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>
              <a:off x="7987019" y="4286324"/>
              <a:ext cx="111611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5523485" y="4067329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6771926" y="4088149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7959660" y="4068021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Group 94"/>
          <p:cNvGrpSpPr/>
          <p:nvPr/>
        </p:nvGrpSpPr>
        <p:grpSpPr>
          <a:xfrm>
            <a:off x="152401" y="5378972"/>
            <a:ext cx="3886199" cy="850122"/>
            <a:chOff x="4745279" y="64401"/>
            <a:chExt cx="4371682" cy="850122"/>
          </a:xfrm>
        </p:grpSpPr>
        <p:pic>
          <p:nvPicPr>
            <p:cNvPr id="96" name="Picture 95"/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56219" y="364452"/>
              <a:ext cx="3657600" cy="276606"/>
            </a:xfrm>
            <a:prstGeom prst="rect">
              <a:avLst/>
            </a:prstGeom>
          </p:spPr>
        </p:pic>
        <p:sp>
          <p:nvSpPr>
            <p:cNvPr id="97" name="TextBox 96"/>
            <p:cNvSpPr txBox="1"/>
            <p:nvPr/>
          </p:nvSpPr>
          <p:spPr>
            <a:xfrm>
              <a:off x="4745279" y="400429"/>
              <a:ext cx="10206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VDAC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8" name="Picture 97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50948" y="638354"/>
              <a:ext cx="3657600" cy="270463"/>
            </a:xfrm>
            <a:prstGeom prst="rect">
              <a:avLst/>
            </a:prstGeom>
          </p:spPr>
        </p:pic>
        <p:sp>
          <p:nvSpPr>
            <p:cNvPr id="99" name="TextBox 98"/>
            <p:cNvSpPr txBox="1"/>
            <p:nvPr/>
          </p:nvSpPr>
          <p:spPr>
            <a:xfrm>
              <a:off x="4792254" y="668302"/>
              <a:ext cx="7619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Straight Connector 99"/>
            <p:cNvCxnSpPr/>
            <p:nvPr/>
          </p:nvCxnSpPr>
          <p:spPr>
            <a:xfrm>
              <a:off x="5449315" y="299217"/>
              <a:ext cx="1143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6739246" y="299217"/>
              <a:ext cx="110535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>
              <a:off x="7959660" y="299217"/>
              <a:ext cx="1143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/>
            <p:cNvSpPr txBox="1"/>
            <p:nvPr/>
          </p:nvSpPr>
          <p:spPr>
            <a:xfrm>
              <a:off x="5516751" y="76200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6810976" y="64401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8011046" y="64401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6" name="Group 105"/>
          <p:cNvGrpSpPr/>
          <p:nvPr/>
        </p:nvGrpSpPr>
        <p:grpSpPr>
          <a:xfrm>
            <a:off x="4724400" y="5350595"/>
            <a:ext cx="3845961" cy="915426"/>
            <a:chOff x="4810540" y="1182415"/>
            <a:chExt cx="4282382" cy="915426"/>
          </a:xfrm>
        </p:grpSpPr>
        <p:pic>
          <p:nvPicPr>
            <p:cNvPr id="107" name="Picture 106"/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731" b="4773"/>
            <a:stretch/>
          </p:blipFill>
          <p:spPr>
            <a:xfrm>
              <a:off x="5478448" y="1492611"/>
              <a:ext cx="3614474" cy="273345"/>
            </a:xfrm>
            <a:prstGeom prst="rect">
              <a:avLst/>
            </a:prstGeom>
          </p:spPr>
        </p:pic>
        <p:pic>
          <p:nvPicPr>
            <p:cNvPr id="108" name="Picture 107"/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15" t="14611" r="19942" b="72750"/>
            <a:stretch/>
          </p:blipFill>
          <p:spPr>
            <a:xfrm>
              <a:off x="5478448" y="1767925"/>
              <a:ext cx="3614474" cy="273818"/>
            </a:xfrm>
            <a:prstGeom prst="rect">
              <a:avLst/>
            </a:prstGeom>
          </p:spPr>
        </p:pic>
        <p:sp>
          <p:nvSpPr>
            <p:cNvPr id="109" name="TextBox 108"/>
            <p:cNvSpPr txBox="1"/>
            <p:nvPr/>
          </p:nvSpPr>
          <p:spPr>
            <a:xfrm>
              <a:off x="4852483" y="1546820"/>
              <a:ext cx="8065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DAC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4810540" y="1851620"/>
              <a:ext cx="76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6759110" y="1201090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" name="Straight Connector 110"/>
            <p:cNvCxnSpPr/>
            <p:nvPr/>
          </p:nvCxnSpPr>
          <p:spPr>
            <a:xfrm>
              <a:off x="5478448" y="1415405"/>
              <a:ext cx="1143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6738259" y="1409660"/>
              <a:ext cx="108228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>
              <a:off x="7929509" y="1413644"/>
              <a:ext cx="1130159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/>
            <p:cNvSpPr txBox="1"/>
            <p:nvPr/>
          </p:nvSpPr>
          <p:spPr>
            <a:xfrm>
              <a:off x="5690481" y="1182415"/>
              <a:ext cx="867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7935593" y="1187136"/>
              <a:ext cx="1105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53033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73498" y="1559436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sta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6858000" y="1559436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K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4800600" y="2081294"/>
            <a:ext cx="4007659" cy="1676274"/>
            <a:chOff x="4412495" y="2966474"/>
            <a:chExt cx="4007659" cy="1676274"/>
          </a:xfrm>
        </p:grpSpPr>
        <p:grpSp>
          <p:nvGrpSpPr>
            <p:cNvPr id="5" name="Group 4"/>
            <p:cNvGrpSpPr/>
            <p:nvPr/>
          </p:nvGrpSpPr>
          <p:grpSpPr>
            <a:xfrm>
              <a:off x="4412495" y="2966474"/>
              <a:ext cx="4004600" cy="1664062"/>
              <a:chOff x="-7105" y="3737999"/>
              <a:chExt cx="4004600" cy="1664062"/>
            </a:xfrm>
          </p:grpSpPr>
          <p:cxnSp>
            <p:nvCxnSpPr>
              <p:cNvPr id="10" name="Straight Connector 9"/>
              <p:cNvCxnSpPr/>
              <p:nvPr/>
            </p:nvCxnSpPr>
            <p:spPr>
              <a:xfrm>
                <a:off x="2936791" y="4051594"/>
                <a:ext cx="106070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1" name="Group 10"/>
              <p:cNvGrpSpPr/>
              <p:nvPr/>
            </p:nvGrpSpPr>
            <p:grpSpPr>
              <a:xfrm>
                <a:off x="-7105" y="3737999"/>
                <a:ext cx="3760475" cy="1664062"/>
                <a:chOff x="-7105" y="3052341"/>
                <a:chExt cx="3760475" cy="1664062"/>
              </a:xfrm>
            </p:grpSpPr>
            <p:sp>
              <p:nvSpPr>
                <p:cNvPr id="12" name="TextBox 11"/>
                <p:cNvSpPr txBox="1"/>
                <p:nvPr/>
              </p:nvSpPr>
              <p:spPr>
                <a:xfrm>
                  <a:off x="-6153" y="3401849"/>
                  <a:ext cx="8839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mplex II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-7105" y="3545441"/>
                  <a:ext cx="8839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mplex V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-7105" y="3697022"/>
                  <a:ext cx="8839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mplex III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-7105" y="4244849"/>
                  <a:ext cx="8839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mplex</a:t>
                  </a:r>
                  <a:r>
                    <a:rPr lang="en-US" sz="1000" dirty="0" smtClean="0"/>
                    <a:t> </a:t>
                  </a:r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V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-4330" y="3954446"/>
                  <a:ext cx="8839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mplex I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-4330" y="4470182"/>
                  <a:ext cx="8839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8" name="Straight Connector 17"/>
                <p:cNvCxnSpPr/>
                <p:nvPr/>
              </p:nvCxnSpPr>
              <p:spPr>
                <a:xfrm>
                  <a:off x="778582" y="3366945"/>
                  <a:ext cx="103327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TextBox 18"/>
                <p:cNvSpPr txBox="1"/>
                <p:nvPr/>
              </p:nvSpPr>
              <p:spPr>
                <a:xfrm>
                  <a:off x="1072263" y="3057299"/>
                  <a:ext cx="5334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G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0" name="Straight Connector 19"/>
                <p:cNvCxnSpPr/>
                <p:nvPr/>
              </p:nvCxnSpPr>
              <p:spPr>
                <a:xfrm>
                  <a:off x="1843564" y="3365936"/>
                  <a:ext cx="104241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TextBox 20"/>
                <p:cNvSpPr txBox="1"/>
                <p:nvPr/>
              </p:nvSpPr>
              <p:spPr>
                <a:xfrm>
                  <a:off x="2132051" y="3057737"/>
                  <a:ext cx="60253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G 1h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3173774" y="3052341"/>
                  <a:ext cx="57959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G 4h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6" name="Group 5"/>
            <p:cNvGrpSpPr/>
            <p:nvPr/>
          </p:nvGrpSpPr>
          <p:grpSpPr>
            <a:xfrm>
              <a:off x="5171444" y="3364506"/>
              <a:ext cx="3248710" cy="1278242"/>
              <a:chOff x="5171444" y="3364506"/>
              <a:chExt cx="3248710" cy="1278242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89" t="33995" r="15215" b="30794"/>
              <a:stretch/>
            </p:blipFill>
            <p:spPr>
              <a:xfrm>
                <a:off x="5174034" y="3364506"/>
                <a:ext cx="3246120" cy="743903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65" t="17647" r="16727" b="70588"/>
              <a:stretch/>
            </p:blipFill>
            <p:spPr>
              <a:xfrm>
                <a:off x="5174034" y="4377759"/>
                <a:ext cx="3246120" cy="264989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677" t="16443" r="15215" b="50000"/>
              <a:stretch/>
            </p:blipFill>
            <p:spPr>
              <a:xfrm>
                <a:off x="5171444" y="4110195"/>
                <a:ext cx="3246120" cy="264989"/>
              </a:xfrm>
              <a:prstGeom prst="rect">
                <a:avLst/>
              </a:prstGeom>
            </p:spPr>
          </p:pic>
        </p:grpSp>
      </p:grpSp>
      <p:grpSp>
        <p:nvGrpSpPr>
          <p:cNvPr id="23" name="Group 22"/>
          <p:cNvGrpSpPr/>
          <p:nvPr/>
        </p:nvGrpSpPr>
        <p:grpSpPr>
          <a:xfrm>
            <a:off x="128646" y="2073333"/>
            <a:ext cx="4036447" cy="2193867"/>
            <a:chOff x="-148429" y="3047997"/>
            <a:chExt cx="4036447" cy="2193867"/>
          </a:xfrm>
        </p:grpSpPr>
        <p:grpSp>
          <p:nvGrpSpPr>
            <p:cNvPr id="24" name="Group 23"/>
            <p:cNvGrpSpPr/>
            <p:nvPr/>
          </p:nvGrpSpPr>
          <p:grpSpPr>
            <a:xfrm>
              <a:off x="-148429" y="3047997"/>
              <a:ext cx="4036447" cy="2193867"/>
              <a:chOff x="-76990" y="3326833"/>
              <a:chExt cx="4036447" cy="1610662"/>
            </a:xfrm>
          </p:grpSpPr>
          <p:grpSp>
            <p:nvGrpSpPr>
              <p:cNvPr id="26" name="Group 25"/>
              <p:cNvGrpSpPr/>
              <p:nvPr/>
            </p:nvGrpSpPr>
            <p:grpSpPr>
              <a:xfrm>
                <a:off x="-76990" y="3326833"/>
                <a:ext cx="4036447" cy="1592392"/>
                <a:chOff x="227810" y="1255073"/>
                <a:chExt cx="4036447" cy="1592392"/>
              </a:xfrm>
            </p:grpSpPr>
            <p:sp>
              <p:nvSpPr>
                <p:cNvPr id="28" name="TextBox 27"/>
                <p:cNvSpPr txBox="1"/>
                <p:nvPr/>
              </p:nvSpPr>
              <p:spPr>
                <a:xfrm>
                  <a:off x="227810" y="1603070"/>
                  <a:ext cx="8839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mplex V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227810" y="1699152"/>
                  <a:ext cx="8839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mplex III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228600" y="2395872"/>
                  <a:ext cx="8839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mplex IV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1" name="Group 30"/>
                <p:cNvGrpSpPr/>
                <p:nvPr/>
              </p:nvGrpSpPr>
              <p:grpSpPr>
                <a:xfrm>
                  <a:off x="228601" y="1255073"/>
                  <a:ext cx="4035656" cy="1592392"/>
                  <a:chOff x="228601" y="1255073"/>
                  <a:chExt cx="4035656" cy="1592392"/>
                </a:xfrm>
              </p:grpSpPr>
              <p:sp>
                <p:nvSpPr>
                  <p:cNvPr id="32" name="TextBox 31"/>
                  <p:cNvSpPr txBox="1"/>
                  <p:nvPr/>
                </p:nvSpPr>
                <p:spPr>
                  <a:xfrm>
                    <a:off x="228601" y="1519442"/>
                    <a:ext cx="88392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mplex II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229019" y="1797829"/>
                    <a:ext cx="88392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mplex I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4" name="Straight Connector 33"/>
                  <p:cNvCxnSpPr/>
                  <p:nvPr/>
                </p:nvCxnSpPr>
                <p:spPr>
                  <a:xfrm>
                    <a:off x="1034517" y="1488094"/>
                    <a:ext cx="100584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1270737" y="1255074"/>
                    <a:ext cx="5334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G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6" name="Straight Connector 35"/>
                  <p:cNvCxnSpPr/>
                  <p:nvPr/>
                </p:nvCxnSpPr>
                <p:spPr>
                  <a:xfrm>
                    <a:off x="2133599" y="1488094"/>
                    <a:ext cx="1024128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7" name="TextBox 36"/>
                  <p:cNvSpPr txBox="1"/>
                  <p:nvPr/>
                </p:nvSpPr>
                <p:spPr>
                  <a:xfrm>
                    <a:off x="2313287" y="1255074"/>
                    <a:ext cx="59665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G 1h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3335763" y="1255073"/>
                    <a:ext cx="56863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G 4h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9" name="Straight Connector 38"/>
                  <p:cNvCxnSpPr/>
                  <p:nvPr/>
                </p:nvCxnSpPr>
                <p:spPr>
                  <a:xfrm>
                    <a:off x="3216014" y="1488094"/>
                    <a:ext cx="100584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40" name="Picture 39"/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0584" t="11573" r="5927" b="68653"/>
                  <a:stretch/>
                </p:blipFill>
                <p:spPr>
                  <a:xfrm>
                    <a:off x="1018137" y="2527424"/>
                    <a:ext cx="3246120" cy="320041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27" name="TextBox 26"/>
              <p:cNvSpPr txBox="1"/>
              <p:nvPr/>
            </p:nvSpPr>
            <p:spPr>
              <a:xfrm>
                <a:off x="-76200" y="4691274"/>
                <a:ext cx="7016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1754" y="3479802"/>
              <a:ext cx="3246120" cy="1303254"/>
            </a:xfrm>
            <a:prstGeom prst="rect">
              <a:avLst/>
            </a:prstGeom>
          </p:spPr>
        </p:pic>
      </p:grpSp>
      <p:sp>
        <p:nvSpPr>
          <p:cNvPr id="43" name="TextBox 42"/>
          <p:cNvSpPr txBox="1"/>
          <p:nvPr/>
        </p:nvSpPr>
        <p:spPr>
          <a:xfrm>
            <a:off x="152399" y="0"/>
            <a:ext cx="82296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lots to support Figure 5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37774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3799" y="1834673"/>
            <a:ext cx="3822401" cy="935311"/>
            <a:chOff x="270723" y="4607093"/>
            <a:chExt cx="4151469" cy="93531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02" t="71168" r="12190" b="18248"/>
            <a:stretch/>
          </p:blipFill>
          <p:spPr>
            <a:xfrm>
              <a:off x="896616" y="4973737"/>
              <a:ext cx="3525576" cy="287631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270724" y="5007279"/>
              <a:ext cx="7221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nSOD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Straight Connector 4"/>
            <p:cNvCxnSpPr/>
            <p:nvPr/>
          </p:nvCxnSpPr>
          <p:spPr>
            <a:xfrm>
              <a:off x="914400" y="4891845"/>
              <a:ext cx="1143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1232754" y="4630579"/>
              <a:ext cx="5925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2087903" y="4891845"/>
              <a:ext cx="1102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3230624" y="4891845"/>
              <a:ext cx="1143001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2316877" y="4623450"/>
              <a:ext cx="8092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363270" y="4607093"/>
              <a:ext cx="8680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27" t="47709" r="10678" b="41707"/>
            <a:stretch/>
          </p:blipFill>
          <p:spPr>
            <a:xfrm>
              <a:off x="896616" y="5254773"/>
              <a:ext cx="3525576" cy="287631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70723" y="5239188"/>
              <a:ext cx="76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83797" y="3132729"/>
            <a:ext cx="3802403" cy="905871"/>
            <a:chOff x="4820570" y="4351871"/>
            <a:chExt cx="4129749" cy="905871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34" t="64488" r="4699" b="18131"/>
            <a:stretch/>
          </p:blipFill>
          <p:spPr>
            <a:xfrm>
              <a:off x="5424743" y="4963944"/>
              <a:ext cx="3525576" cy="293798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4820570" y="5000023"/>
              <a:ext cx="76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22" t="43820" b="37639"/>
            <a:stretch/>
          </p:blipFill>
          <p:spPr>
            <a:xfrm>
              <a:off x="5424743" y="4675342"/>
              <a:ext cx="3525576" cy="291691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4820570" y="4714241"/>
              <a:ext cx="6777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CP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5449218" y="4601507"/>
              <a:ext cx="116681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6682426" y="4598092"/>
              <a:ext cx="10763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7817349" y="4598092"/>
              <a:ext cx="11122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7924072" y="4351871"/>
              <a:ext cx="8048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865306" y="4351871"/>
              <a:ext cx="7686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803895" y="4351871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4572000" y="1887108"/>
            <a:ext cx="3848154" cy="870472"/>
            <a:chOff x="248636" y="3348127"/>
            <a:chExt cx="4138618" cy="870472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609" t="85618" b="3798"/>
            <a:stretch/>
          </p:blipFill>
          <p:spPr>
            <a:xfrm>
              <a:off x="896113" y="3643619"/>
              <a:ext cx="3491141" cy="287405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248636" y="3693554"/>
              <a:ext cx="76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nSOD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74" t="42998" r="1694" b="42184"/>
            <a:stretch/>
          </p:blipFill>
          <p:spPr>
            <a:xfrm>
              <a:off x="896112" y="3931507"/>
              <a:ext cx="3491141" cy="287092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249568" y="3964949"/>
              <a:ext cx="76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Straight Connector 28"/>
            <p:cNvCxnSpPr/>
            <p:nvPr/>
          </p:nvCxnSpPr>
          <p:spPr>
            <a:xfrm>
              <a:off x="914400" y="3575095"/>
              <a:ext cx="11801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2170653" y="3574856"/>
              <a:ext cx="10325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3287404" y="3574856"/>
              <a:ext cx="10763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1258062" y="3353512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332628" y="3348127"/>
              <a:ext cx="7381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475381" y="3353512"/>
              <a:ext cx="6750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4614783" y="3111693"/>
            <a:ext cx="3809295" cy="895016"/>
            <a:chOff x="4790229" y="3322005"/>
            <a:chExt cx="4096826" cy="895016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364"/>
            <a:stretch/>
          </p:blipFill>
          <p:spPr>
            <a:xfrm>
              <a:off x="5395914" y="3642211"/>
              <a:ext cx="3491141" cy="287405"/>
            </a:xfrm>
            <a:prstGeom prst="rect">
              <a:avLst/>
            </a:prstGeom>
          </p:spPr>
        </p:pic>
        <p:sp>
          <p:nvSpPr>
            <p:cNvPr id="37" name="TextBox 36"/>
            <p:cNvSpPr txBox="1"/>
            <p:nvPr/>
          </p:nvSpPr>
          <p:spPr>
            <a:xfrm>
              <a:off x="4790229" y="3662047"/>
              <a:ext cx="609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CP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5422777" y="3568226"/>
              <a:ext cx="113093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5774913" y="3322005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6632336" y="3568226"/>
              <a:ext cx="10325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6850272" y="3322005"/>
              <a:ext cx="6940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Straight Connector 41"/>
            <p:cNvCxnSpPr/>
            <p:nvPr/>
          </p:nvCxnSpPr>
          <p:spPr>
            <a:xfrm>
              <a:off x="7727071" y="3569655"/>
              <a:ext cx="113223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7902888" y="3327113"/>
              <a:ext cx="8048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Picture 4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584"/>
            <a:stretch/>
          </p:blipFill>
          <p:spPr>
            <a:xfrm>
              <a:off x="5391693" y="3929616"/>
              <a:ext cx="3491141" cy="287405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4801733" y="3966847"/>
              <a:ext cx="76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1828800" y="1305801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sta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553200" y="1312880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K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52399" y="0"/>
            <a:ext cx="8382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II: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lots to support Figure 5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5368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953000" y="1460189"/>
            <a:ext cx="3851610" cy="906086"/>
            <a:chOff x="4729541" y="4517600"/>
            <a:chExt cx="4784186" cy="90608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81636" y="4838179"/>
              <a:ext cx="4032091" cy="294582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4743217" y="4830658"/>
              <a:ext cx="1027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Mfn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69" t="9425" r="765" b="74702"/>
            <a:stretch/>
          </p:blipFill>
          <p:spPr>
            <a:xfrm>
              <a:off x="5475834" y="5129104"/>
              <a:ext cx="4032091" cy="294582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729541" y="5087059"/>
              <a:ext cx="8629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5506866" y="4749756"/>
              <a:ext cx="1249380" cy="1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5833494" y="4517600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>
              <a:off x="6867483" y="4748051"/>
              <a:ext cx="1249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7131283" y="4521595"/>
              <a:ext cx="721193" cy="2467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8231628" y="4749930"/>
              <a:ext cx="1249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8335317" y="4518372"/>
              <a:ext cx="7851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5029200" y="2438694"/>
            <a:ext cx="3783078" cy="918181"/>
            <a:chOff x="4828955" y="5696334"/>
            <a:chExt cx="4699061" cy="918181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1675" b="50607"/>
            <a:stretch/>
          </p:blipFill>
          <p:spPr>
            <a:xfrm>
              <a:off x="5495924" y="6012913"/>
              <a:ext cx="4032092" cy="300577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1" b="21384"/>
            <a:stretch/>
          </p:blipFill>
          <p:spPr>
            <a:xfrm>
              <a:off x="5495922" y="6313938"/>
              <a:ext cx="4032093" cy="300577"/>
            </a:xfrm>
            <a:prstGeom prst="rect">
              <a:avLst/>
            </a:prstGeom>
          </p:spPr>
        </p:pic>
        <p:cxnSp>
          <p:nvCxnSpPr>
            <p:cNvPr id="16" name="Straight Connector 15"/>
            <p:cNvCxnSpPr/>
            <p:nvPr/>
          </p:nvCxnSpPr>
          <p:spPr>
            <a:xfrm>
              <a:off x="5495923" y="5957786"/>
              <a:ext cx="1306170" cy="1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5845659" y="5696539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6909145" y="5957506"/>
              <a:ext cx="1249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7102144" y="5700009"/>
              <a:ext cx="751219" cy="2460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8236393" y="5956458"/>
              <a:ext cx="1249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8340081" y="5696334"/>
              <a:ext cx="782422" cy="2464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828955" y="6278009"/>
              <a:ext cx="8988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828955" y="6001010"/>
              <a:ext cx="8709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fn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4880942" y="3500004"/>
            <a:ext cx="3910742" cy="923671"/>
            <a:chOff x="4736873" y="1604187"/>
            <a:chExt cx="4742168" cy="923671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26" t="60593" r="7652" b="18220"/>
            <a:stretch/>
          </p:blipFill>
          <p:spPr>
            <a:xfrm>
              <a:off x="5540744" y="1934800"/>
              <a:ext cx="3936247" cy="297897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4736873" y="1928291"/>
              <a:ext cx="8206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OPA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65" t="11158" r="4628" b="71186"/>
            <a:stretch/>
          </p:blipFill>
          <p:spPr>
            <a:xfrm>
              <a:off x="5542794" y="2228850"/>
              <a:ext cx="3936247" cy="299008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4829273" y="2202313"/>
              <a:ext cx="8206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Straight Connector 28"/>
            <p:cNvCxnSpPr/>
            <p:nvPr/>
          </p:nvCxnSpPr>
          <p:spPr>
            <a:xfrm>
              <a:off x="5555974" y="1873952"/>
              <a:ext cx="119600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5841308" y="1625178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6914715" y="1871399"/>
              <a:ext cx="12196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7073759" y="1606188"/>
              <a:ext cx="7963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8243094" y="1871399"/>
              <a:ext cx="12196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8344316" y="1604187"/>
              <a:ext cx="7695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96905" y="1416009"/>
            <a:ext cx="3804895" cy="950266"/>
            <a:chOff x="4841384" y="3075801"/>
            <a:chExt cx="4304606" cy="887500"/>
          </a:xfrm>
        </p:grpSpPr>
        <p:pic>
          <p:nvPicPr>
            <p:cNvPr id="59" name="Picture 58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5000" contrast="-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0612"/>
            <a:stretch/>
          </p:blipFill>
          <p:spPr>
            <a:xfrm>
              <a:off x="5473545" y="3427201"/>
              <a:ext cx="3672445" cy="268236"/>
            </a:xfrm>
            <a:prstGeom prst="rect">
              <a:avLst/>
            </a:prstGeom>
          </p:spPr>
        </p:pic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11" t="18468" r="4873" b="71470"/>
            <a:stretch/>
          </p:blipFill>
          <p:spPr>
            <a:xfrm>
              <a:off x="5473545" y="3689738"/>
              <a:ext cx="3672445" cy="268236"/>
            </a:xfrm>
            <a:prstGeom prst="rect">
              <a:avLst/>
            </a:prstGeom>
          </p:spPr>
        </p:pic>
        <p:sp>
          <p:nvSpPr>
            <p:cNvPr id="61" name="TextBox 60"/>
            <p:cNvSpPr txBox="1"/>
            <p:nvPr/>
          </p:nvSpPr>
          <p:spPr>
            <a:xfrm>
              <a:off x="4841385" y="3449930"/>
              <a:ext cx="683647" cy="272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fn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841384" y="3691338"/>
              <a:ext cx="755432" cy="2719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3" name="Straight Connector 62"/>
            <p:cNvCxnSpPr/>
            <p:nvPr/>
          </p:nvCxnSpPr>
          <p:spPr>
            <a:xfrm>
              <a:off x="5481635" y="3340925"/>
              <a:ext cx="1147765" cy="1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/>
            <p:cNvSpPr txBox="1"/>
            <p:nvPr/>
          </p:nvSpPr>
          <p:spPr>
            <a:xfrm>
              <a:off x="5844207" y="3105966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6991972" y="3075876"/>
              <a:ext cx="6311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Straight Connector 65"/>
            <p:cNvCxnSpPr/>
            <p:nvPr/>
          </p:nvCxnSpPr>
          <p:spPr>
            <a:xfrm>
              <a:off x="6774968" y="3340925"/>
              <a:ext cx="10966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8005662" y="3340925"/>
              <a:ext cx="111218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/>
            <p:cNvSpPr txBox="1"/>
            <p:nvPr/>
          </p:nvSpPr>
          <p:spPr>
            <a:xfrm>
              <a:off x="8158062" y="3075801"/>
              <a:ext cx="6311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9" name="Group 68"/>
          <p:cNvGrpSpPr/>
          <p:nvPr/>
        </p:nvGrpSpPr>
        <p:grpSpPr>
          <a:xfrm>
            <a:off x="152400" y="2442475"/>
            <a:ext cx="3746920" cy="914400"/>
            <a:chOff x="365528" y="5484618"/>
            <a:chExt cx="4239015" cy="958616"/>
          </a:xfrm>
        </p:grpSpPr>
        <p:pic>
          <p:nvPicPr>
            <p:cNvPr id="70" name="Picture 69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513" b="22882"/>
            <a:stretch/>
          </p:blipFill>
          <p:spPr>
            <a:xfrm>
              <a:off x="932100" y="5866233"/>
              <a:ext cx="3672443" cy="268235"/>
            </a:xfrm>
            <a:prstGeom prst="rect">
              <a:avLst/>
            </a:prstGeom>
          </p:spPr>
        </p:pic>
        <p:pic>
          <p:nvPicPr>
            <p:cNvPr id="71" name="Picture 70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8686" y="6133383"/>
              <a:ext cx="3672443" cy="280567"/>
            </a:xfrm>
            <a:prstGeom prst="rect">
              <a:avLst/>
            </a:prstGeom>
          </p:spPr>
        </p:pic>
        <p:sp>
          <p:nvSpPr>
            <p:cNvPr id="72" name="TextBox 71"/>
            <p:cNvSpPr txBox="1"/>
            <p:nvPr/>
          </p:nvSpPr>
          <p:spPr>
            <a:xfrm>
              <a:off x="365528" y="5890534"/>
              <a:ext cx="673078" cy="272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fn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65528" y="6170417"/>
              <a:ext cx="759369" cy="272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Straight Connector 73"/>
            <p:cNvCxnSpPr/>
            <p:nvPr/>
          </p:nvCxnSpPr>
          <p:spPr>
            <a:xfrm>
              <a:off x="928686" y="5754598"/>
              <a:ext cx="11754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/>
            <p:cNvSpPr txBox="1"/>
            <p:nvPr/>
          </p:nvSpPr>
          <p:spPr>
            <a:xfrm>
              <a:off x="1241729" y="5502840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Straight Connector 75"/>
            <p:cNvCxnSpPr/>
            <p:nvPr/>
          </p:nvCxnSpPr>
          <p:spPr>
            <a:xfrm>
              <a:off x="2217254" y="5754598"/>
              <a:ext cx="10866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>
              <a:off x="2421635" y="5498784"/>
              <a:ext cx="6311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Straight Connector 77"/>
            <p:cNvCxnSpPr/>
            <p:nvPr/>
          </p:nvCxnSpPr>
          <p:spPr>
            <a:xfrm>
              <a:off x="3405185" y="5754598"/>
              <a:ext cx="11811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/>
            <p:cNvSpPr txBox="1"/>
            <p:nvPr/>
          </p:nvSpPr>
          <p:spPr>
            <a:xfrm>
              <a:off x="3595686" y="5484618"/>
              <a:ext cx="6311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Group 90"/>
          <p:cNvGrpSpPr/>
          <p:nvPr/>
        </p:nvGrpSpPr>
        <p:grpSpPr>
          <a:xfrm>
            <a:off x="152400" y="3433075"/>
            <a:ext cx="3748134" cy="965034"/>
            <a:chOff x="4918454" y="86066"/>
            <a:chExt cx="4240388" cy="949456"/>
          </a:xfrm>
        </p:grpSpPr>
        <p:pic>
          <p:nvPicPr>
            <p:cNvPr id="92" name="Picture 91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03" t="50000" r="10678" b="13636"/>
            <a:stretch/>
          </p:blipFill>
          <p:spPr>
            <a:xfrm>
              <a:off x="5486398" y="487708"/>
              <a:ext cx="3672443" cy="281293"/>
            </a:xfrm>
            <a:prstGeom prst="rect">
              <a:avLst/>
            </a:prstGeom>
          </p:spPr>
        </p:pic>
        <p:pic>
          <p:nvPicPr>
            <p:cNvPr id="93" name="Picture 92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78" t="6467" r="12190" b="77985"/>
            <a:stretch/>
          </p:blipFill>
          <p:spPr>
            <a:xfrm>
              <a:off x="5486399" y="762706"/>
              <a:ext cx="3672443" cy="271208"/>
            </a:xfrm>
            <a:prstGeom prst="rect">
              <a:avLst/>
            </a:prstGeom>
          </p:spPr>
        </p:pic>
        <p:sp>
          <p:nvSpPr>
            <p:cNvPr id="94" name="TextBox 93"/>
            <p:cNvSpPr txBox="1"/>
            <p:nvPr/>
          </p:nvSpPr>
          <p:spPr>
            <a:xfrm>
              <a:off x="4918455" y="497727"/>
              <a:ext cx="645101" cy="272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PA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4918454" y="762706"/>
              <a:ext cx="818463" cy="272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6" name="Straight Connector 95"/>
            <p:cNvCxnSpPr/>
            <p:nvPr/>
          </p:nvCxnSpPr>
          <p:spPr>
            <a:xfrm>
              <a:off x="5509591" y="381000"/>
              <a:ext cx="119600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/>
            <p:cNvSpPr txBox="1"/>
            <p:nvPr/>
          </p:nvSpPr>
          <p:spPr>
            <a:xfrm>
              <a:off x="5840895" y="92404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Straight Connector 97"/>
            <p:cNvCxnSpPr/>
            <p:nvPr/>
          </p:nvCxnSpPr>
          <p:spPr>
            <a:xfrm>
              <a:off x="6781800" y="381000"/>
              <a:ext cx="106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/>
            <p:cNvSpPr txBox="1"/>
            <p:nvPr/>
          </p:nvSpPr>
          <p:spPr>
            <a:xfrm>
              <a:off x="6999631" y="86066"/>
              <a:ext cx="6311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1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Straight Connector 99"/>
            <p:cNvCxnSpPr/>
            <p:nvPr/>
          </p:nvCxnSpPr>
          <p:spPr>
            <a:xfrm>
              <a:off x="7933686" y="381000"/>
              <a:ext cx="11795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/>
            <p:cNvSpPr txBox="1"/>
            <p:nvPr/>
          </p:nvSpPr>
          <p:spPr>
            <a:xfrm>
              <a:off x="8153400" y="95258"/>
              <a:ext cx="6311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G 4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3" name="TextBox 112"/>
          <p:cNvSpPr txBox="1"/>
          <p:nvPr/>
        </p:nvSpPr>
        <p:spPr>
          <a:xfrm>
            <a:off x="1828800" y="926068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sta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6858000" y="926068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K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42744" y="54114"/>
            <a:ext cx="83478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V: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lots to support Figure 5D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05455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6400800" y="1154668"/>
            <a:ext cx="893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K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377154" y="1154668"/>
            <a:ext cx="1432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sta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9" name="Group 118"/>
          <p:cNvGrpSpPr/>
          <p:nvPr/>
        </p:nvGrpSpPr>
        <p:grpSpPr>
          <a:xfrm>
            <a:off x="1388362" y="1708864"/>
            <a:ext cx="2400302" cy="702083"/>
            <a:chOff x="650746" y="565864"/>
            <a:chExt cx="2400302" cy="702083"/>
          </a:xfrm>
        </p:grpSpPr>
        <p:grpSp>
          <p:nvGrpSpPr>
            <p:cNvPr id="25" name="Group 24"/>
            <p:cNvGrpSpPr/>
            <p:nvPr/>
          </p:nvGrpSpPr>
          <p:grpSpPr>
            <a:xfrm>
              <a:off x="650746" y="565864"/>
              <a:ext cx="2400302" cy="702083"/>
              <a:chOff x="3086098" y="2726917"/>
              <a:chExt cx="2400302" cy="702083"/>
            </a:xfrm>
          </p:grpSpPr>
          <p:pic>
            <p:nvPicPr>
              <p:cNvPr id="15" name="Picture 1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271" t="33553" r="19789" b="59868"/>
              <a:stretch/>
            </p:blipFill>
            <p:spPr>
              <a:xfrm>
                <a:off x="3581400" y="3048000"/>
                <a:ext cx="1905000" cy="152400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005" t="39599" r="18620" b="49841"/>
              <a:stretch/>
            </p:blipFill>
            <p:spPr>
              <a:xfrm>
                <a:off x="3581400" y="3200400"/>
                <a:ext cx="1905000" cy="228600"/>
              </a:xfrm>
              <a:prstGeom prst="rect">
                <a:avLst/>
              </a:prstGeom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3695700" y="2726917"/>
                <a:ext cx="381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256816" y="2732001"/>
                <a:ext cx="5572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1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906803" y="2728712"/>
                <a:ext cx="5572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4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086098" y="2984421"/>
                <a:ext cx="5334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ecl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3086098" y="3150394"/>
                <a:ext cx="5715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55" name="Straight Connector 54"/>
            <p:cNvCxnSpPr/>
            <p:nvPr/>
          </p:nvCxnSpPr>
          <p:spPr>
            <a:xfrm>
              <a:off x="1146048" y="822108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>
              <a:off x="1779461" y="822108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2375630" y="822108"/>
              <a:ext cx="6242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 5"/>
          <p:cNvGrpSpPr/>
          <p:nvPr/>
        </p:nvGrpSpPr>
        <p:grpSpPr>
          <a:xfrm>
            <a:off x="1388362" y="2649379"/>
            <a:ext cx="2397254" cy="703421"/>
            <a:chOff x="650746" y="1506379"/>
            <a:chExt cx="2397254" cy="703421"/>
          </a:xfrm>
        </p:grpSpPr>
        <p:grpSp>
          <p:nvGrpSpPr>
            <p:cNvPr id="51" name="Group 50"/>
            <p:cNvGrpSpPr/>
            <p:nvPr/>
          </p:nvGrpSpPr>
          <p:grpSpPr>
            <a:xfrm>
              <a:off x="650746" y="1506379"/>
              <a:ext cx="2397254" cy="703421"/>
              <a:chOff x="650746" y="1506379"/>
              <a:chExt cx="2397254" cy="703421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1295400" y="1506379"/>
                <a:ext cx="381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0" name="Group 49"/>
              <p:cNvGrpSpPr/>
              <p:nvPr/>
            </p:nvGrpSpPr>
            <p:grpSpPr>
              <a:xfrm>
                <a:off x="650746" y="1506379"/>
                <a:ext cx="2397254" cy="703421"/>
                <a:chOff x="650746" y="1506379"/>
                <a:chExt cx="2397254" cy="703421"/>
              </a:xfrm>
            </p:grpSpPr>
            <p:grpSp>
              <p:nvGrpSpPr>
                <p:cNvPr id="44" name="Group 43"/>
                <p:cNvGrpSpPr/>
                <p:nvPr/>
              </p:nvGrpSpPr>
              <p:grpSpPr>
                <a:xfrm>
                  <a:off x="650746" y="1773001"/>
                  <a:ext cx="2397254" cy="436799"/>
                  <a:chOff x="650746" y="1538223"/>
                  <a:chExt cx="2397254" cy="436799"/>
                </a:xfrm>
              </p:grpSpPr>
              <p:pic>
                <p:nvPicPr>
                  <p:cNvPr id="39" name="Picture 38"/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080" t="38084" r="21308" b="54854"/>
                  <a:stretch/>
                </p:blipFill>
                <p:spPr>
                  <a:xfrm>
                    <a:off x="1146048" y="1561554"/>
                    <a:ext cx="1901952" cy="165387"/>
                  </a:xfrm>
                  <a:prstGeom prst="rect">
                    <a:avLst/>
                  </a:prstGeom>
                </p:spPr>
              </p:pic>
              <p:pic>
                <p:nvPicPr>
                  <p:cNvPr id="40" name="Picture 39"/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1217" t="32345" r="20167" b="57062"/>
                  <a:stretch/>
                </p:blipFill>
                <p:spPr>
                  <a:xfrm>
                    <a:off x="1146048" y="1726941"/>
                    <a:ext cx="1901952" cy="248081"/>
                  </a:xfrm>
                  <a:prstGeom prst="rect">
                    <a:avLst/>
                  </a:prstGeom>
                </p:spPr>
              </p:pic>
              <p:sp>
                <p:nvSpPr>
                  <p:cNvPr id="41" name="TextBox 40"/>
                  <p:cNvSpPr txBox="1"/>
                  <p:nvPr/>
                </p:nvSpPr>
                <p:spPr>
                  <a:xfrm>
                    <a:off x="655512" y="1538223"/>
                    <a:ext cx="490536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62</a:t>
                    </a:r>
                    <a:endParaRPr 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650746" y="1726941"/>
                    <a:ext cx="68580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</a:t>
                    </a:r>
                    <a:r>
                      <a:rPr lang="en-US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actin</a:t>
                    </a:r>
                    <a:endParaRPr 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7" name="TextBox 46"/>
                <p:cNvSpPr txBox="1"/>
                <p:nvPr/>
              </p:nvSpPr>
              <p:spPr>
                <a:xfrm>
                  <a:off x="1818418" y="1506379"/>
                  <a:ext cx="55721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G 1h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2473724" y="1506379"/>
                  <a:ext cx="55721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G 4h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116" name="Straight Connector 115"/>
            <p:cNvCxnSpPr/>
            <p:nvPr/>
          </p:nvCxnSpPr>
          <p:spPr>
            <a:xfrm>
              <a:off x="1170289" y="1726941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>
              <a:off x="1814512" y="1726941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2452266" y="1726941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6" name="Group 125"/>
          <p:cNvGrpSpPr/>
          <p:nvPr/>
        </p:nvGrpSpPr>
        <p:grpSpPr>
          <a:xfrm>
            <a:off x="1379502" y="3639979"/>
            <a:ext cx="2430498" cy="688032"/>
            <a:chOff x="641886" y="2496979"/>
            <a:chExt cx="2430498" cy="688032"/>
          </a:xfrm>
        </p:grpSpPr>
        <p:grpSp>
          <p:nvGrpSpPr>
            <p:cNvPr id="82" name="Group 81"/>
            <p:cNvGrpSpPr/>
            <p:nvPr/>
          </p:nvGrpSpPr>
          <p:grpSpPr>
            <a:xfrm>
              <a:off x="641886" y="2496979"/>
              <a:ext cx="2430498" cy="688032"/>
              <a:chOff x="641886" y="2344579"/>
              <a:chExt cx="2430498" cy="688032"/>
            </a:xfrm>
          </p:grpSpPr>
          <p:grpSp>
            <p:nvGrpSpPr>
              <p:cNvPr id="75" name="Group 74"/>
              <p:cNvGrpSpPr/>
              <p:nvPr/>
            </p:nvGrpSpPr>
            <p:grpSpPr>
              <a:xfrm>
                <a:off x="641886" y="2576793"/>
                <a:ext cx="2430498" cy="455818"/>
                <a:chOff x="641886" y="2290350"/>
                <a:chExt cx="2430498" cy="455818"/>
              </a:xfrm>
            </p:grpSpPr>
            <p:pic>
              <p:nvPicPr>
                <p:cNvPr id="70" name="Picture 69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299" t="74422" r="4902" b="11211"/>
                <a:stretch/>
              </p:blipFill>
              <p:spPr>
                <a:xfrm>
                  <a:off x="1170432" y="2354328"/>
                  <a:ext cx="1901952" cy="211328"/>
                </a:xfrm>
                <a:prstGeom prst="rect">
                  <a:avLst/>
                </a:prstGeom>
              </p:spPr>
            </p:pic>
            <p:sp>
              <p:nvSpPr>
                <p:cNvPr id="71" name="TextBox 70"/>
                <p:cNvSpPr txBox="1"/>
                <p:nvPr/>
              </p:nvSpPr>
              <p:spPr>
                <a:xfrm>
                  <a:off x="650746" y="2290350"/>
                  <a:ext cx="5334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641886" y="2515336"/>
                  <a:ext cx="685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73" name="Picture 72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993" t="42065" r="7536" b="45223"/>
                <a:stretch/>
              </p:blipFill>
              <p:spPr>
                <a:xfrm>
                  <a:off x="1169860" y="2563282"/>
                  <a:ext cx="1901952" cy="163024"/>
                </a:xfrm>
                <a:prstGeom prst="rect">
                  <a:avLst/>
                </a:prstGeom>
              </p:spPr>
            </p:pic>
            <p:sp>
              <p:nvSpPr>
                <p:cNvPr id="74" name="TextBox 73"/>
                <p:cNvSpPr txBox="1"/>
                <p:nvPr/>
              </p:nvSpPr>
              <p:spPr>
                <a:xfrm>
                  <a:off x="650746" y="2392226"/>
                  <a:ext cx="5334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I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9" name="TextBox 78"/>
              <p:cNvSpPr txBox="1"/>
              <p:nvPr/>
            </p:nvSpPr>
            <p:spPr>
              <a:xfrm>
                <a:off x="1299026" y="2344579"/>
                <a:ext cx="381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1827082" y="2344579"/>
                <a:ext cx="5572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1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2476642" y="2344579"/>
                <a:ext cx="5572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4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20" name="Straight Connector 119"/>
            <p:cNvCxnSpPr/>
            <p:nvPr/>
          </p:nvCxnSpPr>
          <p:spPr>
            <a:xfrm>
              <a:off x="1184146" y="2743200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120"/>
            <p:cNvCxnSpPr/>
            <p:nvPr/>
          </p:nvCxnSpPr>
          <p:spPr>
            <a:xfrm>
              <a:off x="1804130" y="2743200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121"/>
            <p:cNvCxnSpPr/>
            <p:nvPr/>
          </p:nvCxnSpPr>
          <p:spPr>
            <a:xfrm>
              <a:off x="2431137" y="2743200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9" name="Group 128"/>
          <p:cNvGrpSpPr/>
          <p:nvPr/>
        </p:nvGrpSpPr>
        <p:grpSpPr>
          <a:xfrm>
            <a:off x="1423416" y="4554379"/>
            <a:ext cx="2386012" cy="627221"/>
            <a:chOff x="685800" y="3411379"/>
            <a:chExt cx="2386012" cy="627221"/>
          </a:xfrm>
        </p:grpSpPr>
        <p:grpSp>
          <p:nvGrpSpPr>
            <p:cNvPr id="94" name="Group 93"/>
            <p:cNvGrpSpPr/>
            <p:nvPr/>
          </p:nvGrpSpPr>
          <p:grpSpPr>
            <a:xfrm>
              <a:off x="685800" y="3411379"/>
              <a:ext cx="2386012" cy="627221"/>
              <a:chOff x="685800" y="3335179"/>
              <a:chExt cx="2386012" cy="627221"/>
            </a:xfrm>
          </p:grpSpPr>
          <p:grpSp>
            <p:nvGrpSpPr>
              <p:cNvPr id="87" name="Group 86"/>
              <p:cNvGrpSpPr/>
              <p:nvPr/>
            </p:nvGrpSpPr>
            <p:grpSpPr>
              <a:xfrm>
                <a:off x="685800" y="3580304"/>
                <a:ext cx="2386012" cy="382096"/>
                <a:chOff x="685800" y="3287945"/>
                <a:chExt cx="2386012" cy="382096"/>
              </a:xfrm>
            </p:grpSpPr>
            <p:pic>
              <p:nvPicPr>
                <p:cNvPr id="83" name="Picture 82"/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69860" y="3357847"/>
                  <a:ext cx="1901952" cy="100787"/>
                </a:xfrm>
                <a:prstGeom prst="rect">
                  <a:avLst/>
                </a:prstGeom>
              </p:spPr>
            </p:pic>
            <p:pic>
              <p:nvPicPr>
                <p:cNvPr id="84" name="Picture 83"/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69860" y="3454549"/>
                  <a:ext cx="1901952" cy="215492"/>
                </a:xfrm>
                <a:prstGeom prst="rect">
                  <a:avLst/>
                </a:prstGeom>
              </p:spPr>
            </p:pic>
            <p:sp>
              <p:nvSpPr>
                <p:cNvPr id="85" name="TextBox 84"/>
                <p:cNvSpPr txBox="1"/>
                <p:nvPr/>
              </p:nvSpPr>
              <p:spPr>
                <a:xfrm>
                  <a:off x="685800" y="3419635"/>
                  <a:ext cx="685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685800" y="3287945"/>
                  <a:ext cx="685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tg7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1" name="TextBox 90"/>
              <p:cNvSpPr txBox="1"/>
              <p:nvPr/>
            </p:nvSpPr>
            <p:spPr>
              <a:xfrm>
                <a:off x="1327686" y="3335179"/>
                <a:ext cx="381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1858917" y="3335179"/>
                <a:ext cx="5572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1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2495585" y="3335179"/>
                <a:ext cx="5572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4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23" name="Straight Connector 122"/>
            <p:cNvCxnSpPr/>
            <p:nvPr/>
          </p:nvCxnSpPr>
          <p:spPr>
            <a:xfrm>
              <a:off x="1194530" y="3661266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Connector 123"/>
            <p:cNvCxnSpPr/>
            <p:nvPr/>
          </p:nvCxnSpPr>
          <p:spPr>
            <a:xfrm>
              <a:off x="1825129" y="3656504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Connector 124"/>
            <p:cNvCxnSpPr/>
            <p:nvPr/>
          </p:nvCxnSpPr>
          <p:spPr>
            <a:xfrm>
              <a:off x="2467545" y="3656504"/>
              <a:ext cx="5611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7" name="Group 136"/>
          <p:cNvGrpSpPr/>
          <p:nvPr/>
        </p:nvGrpSpPr>
        <p:grpSpPr>
          <a:xfrm>
            <a:off x="5256974" y="1641481"/>
            <a:ext cx="2363026" cy="780785"/>
            <a:chOff x="4724400" y="515779"/>
            <a:chExt cx="2363026" cy="780785"/>
          </a:xfrm>
        </p:grpSpPr>
        <p:grpSp>
          <p:nvGrpSpPr>
            <p:cNvPr id="12" name="Group 11"/>
            <p:cNvGrpSpPr/>
            <p:nvPr/>
          </p:nvGrpSpPr>
          <p:grpSpPr>
            <a:xfrm>
              <a:off x="4724400" y="515779"/>
              <a:ext cx="2359152" cy="780785"/>
              <a:chOff x="3124200" y="2645780"/>
              <a:chExt cx="2359152" cy="780785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09" t="28814" r="18253" b="60593"/>
              <a:stretch/>
            </p:blipFill>
            <p:spPr>
              <a:xfrm>
                <a:off x="3581400" y="2971800"/>
                <a:ext cx="1901952" cy="228234"/>
              </a:xfrm>
              <a:prstGeom prst="rect">
                <a:avLst/>
              </a:prstGeom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997" t="38856" r="15128" b="50000"/>
              <a:stretch/>
            </p:blipFill>
            <p:spPr>
              <a:xfrm>
                <a:off x="3581400" y="3195366"/>
                <a:ext cx="1901952" cy="231199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3124200" y="2953813"/>
                <a:ext cx="685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ecl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124200" y="3179180"/>
                <a:ext cx="685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779472" y="2645780"/>
                <a:ext cx="381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267200" y="2645780"/>
                <a:ext cx="5333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1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920947" y="2645780"/>
                <a:ext cx="5333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4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27" name="Straight Connector 126"/>
            <p:cNvCxnSpPr/>
            <p:nvPr/>
          </p:nvCxnSpPr>
          <p:spPr>
            <a:xfrm>
              <a:off x="5221896" y="762000"/>
              <a:ext cx="6104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/>
            <p:cNvCxnSpPr/>
            <p:nvPr/>
          </p:nvCxnSpPr>
          <p:spPr>
            <a:xfrm>
              <a:off x="5872192" y="762000"/>
              <a:ext cx="54915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/>
            <p:cNvCxnSpPr/>
            <p:nvPr/>
          </p:nvCxnSpPr>
          <p:spPr>
            <a:xfrm>
              <a:off x="6476998" y="762000"/>
              <a:ext cx="6104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2" name="Group 141"/>
          <p:cNvGrpSpPr/>
          <p:nvPr/>
        </p:nvGrpSpPr>
        <p:grpSpPr>
          <a:xfrm>
            <a:off x="5214540" y="2590800"/>
            <a:ext cx="2401586" cy="636715"/>
            <a:chOff x="4681966" y="1371600"/>
            <a:chExt cx="2401586" cy="636715"/>
          </a:xfrm>
        </p:grpSpPr>
        <p:grpSp>
          <p:nvGrpSpPr>
            <p:cNvPr id="38" name="Group 37"/>
            <p:cNvGrpSpPr/>
            <p:nvPr/>
          </p:nvGrpSpPr>
          <p:grpSpPr>
            <a:xfrm>
              <a:off x="4681966" y="1371600"/>
              <a:ext cx="2401586" cy="636715"/>
              <a:chOff x="4681966" y="1371600"/>
              <a:chExt cx="2401586" cy="636715"/>
            </a:xfrm>
          </p:grpSpPr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81600" y="1676400"/>
                <a:ext cx="1901952" cy="158221"/>
              </a:xfrm>
              <a:prstGeom prst="rect">
                <a:avLst/>
              </a:prstGeom>
            </p:spPr>
          </p:pic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81600" y="1834621"/>
                <a:ext cx="1901952" cy="131946"/>
              </a:xfrm>
              <a:prstGeom prst="rect">
                <a:avLst/>
              </a:prstGeom>
            </p:spPr>
          </p:pic>
          <p:sp>
            <p:nvSpPr>
              <p:cNvPr id="30" name="TextBox 29"/>
              <p:cNvSpPr txBox="1"/>
              <p:nvPr/>
            </p:nvSpPr>
            <p:spPr>
              <a:xfrm>
                <a:off x="4681966" y="1777483"/>
                <a:ext cx="6858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691064" y="1603831"/>
                <a:ext cx="49053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62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5334000" y="1371600"/>
                <a:ext cx="381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G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5879185" y="1371600"/>
                <a:ext cx="5333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1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6510549" y="1371600"/>
                <a:ext cx="5333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G 4h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33" name="Straight Connector 132"/>
            <p:cNvCxnSpPr/>
            <p:nvPr/>
          </p:nvCxnSpPr>
          <p:spPr>
            <a:xfrm>
              <a:off x="5188558" y="1618118"/>
              <a:ext cx="6104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/>
            <p:cNvCxnSpPr/>
            <p:nvPr/>
          </p:nvCxnSpPr>
          <p:spPr>
            <a:xfrm>
              <a:off x="5833263" y="1618118"/>
              <a:ext cx="6104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/>
            <p:cNvCxnSpPr/>
            <p:nvPr/>
          </p:nvCxnSpPr>
          <p:spPr>
            <a:xfrm>
              <a:off x="6497361" y="1618118"/>
              <a:ext cx="5571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7" name="Group 146"/>
          <p:cNvGrpSpPr/>
          <p:nvPr/>
        </p:nvGrpSpPr>
        <p:grpSpPr>
          <a:xfrm>
            <a:off x="5256425" y="3620632"/>
            <a:ext cx="2359701" cy="722768"/>
            <a:chOff x="4723851" y="2039779"/>
            <a:chExt cx="2359701" cy="722768"/>
          </a:xfrm>
        </p:grpSpPr>
        <p:grpSp>
          <p:nvGrpSpPr>
            <p:cNvPr id="69" name="Group 68"/>
            <p:cNvGrpSpPr/>
            <p:nvPr/>
          </p:nvGrpSpPr>
          <p:grpSpPr>
            <a:xfrm>
              <a:off x="4723851" y="2039779"/>
              <a:ext cx="2359701" cy="722768"/>
              <a:chOff x="4723851" y="2039779"/>
              <a:chExt cx="2359701" cy="722768"/>
            </a:xfrm>
          </p:grpSpPr>
          <p:sp>
            <p:nvSpPr>
              <p:cNvPr id="66" name="TextBox 65"/>
              <p:cNvSpPr txBox="1"/>
              <p:nvPr/>
            </p:nvSpPr>
            <p:spPr>
              <a:xfrm>
                <a:off x="4726781" y="2392226"/>
                <a:ext cx="5334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8" name="Group 67"/>
              <p:cNvGrpSpPr/>
              <p:nvPr/>
            </p:nvGrpSpPr>
            <p:grpSpPr>
              <a:xfrm>
                <a:off x="4723851" y="2039779"/>
                <a:ext cx="2359701" cy="722768"/>
                <a:chOff x="4723851" y="2039779"/>
                <a:chExt cx="2359701" cy="722768"/>
              </a:xfrm>
            </p:grpSpPr>
            <p:grpSp>
              <p:nvGrpSpPr>
                <p:cNvPr id="56" name="Group 55"/>
                <p:cNvGrpSpPr/>
                <p:nvPr/>
              </p:nvGrpSpPr>
              <p:grpSpPr>
                <a:xfrm>
                  <a:off x="5181600" y="2372958"/>
                  <a:ext cx="1901952" cy="370242"/>
                  <a:chOff x="5181600" y="2190007"/>
                  <a:chExt cx="1901952" cy="370242"/>
                </a:xfrm>
              </p:grpSpPr>
              <p:pic>
                <p:nvPicPr>
                  <p:cNvPr id="52" name="Picture 51"/>
                  <p:cNvPicPr>
                    <a:picLocks noChangeAspect="1"/>
                  </p:cNvPicPr>
                  <p:nvPr/>
                </p:nvPicPr>
                <p:blipFill rotWithShape="1">
                  <a:blip r:embed="rId1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2371" t="65674" r="5315" b="18652"/>
                  <a:stretch/>
                </p:blipFill>
                <p:spPr>
                  <a:xfrm>
                    <a:off x="5181600" y="2190007"/>
                    <a:ext cx="1901952" cy="217366"/>
                  </a:xfrm>
                  <a:prstGeom prst="rect">
                    <a:avLst/>
                  </a:prstGeom>
                </p:spPr>
              </p:pic>
              <p:pic>
                <p:nvPicPr>
                  <p:cNvPr id="54" name="Picture 53"/>
                  <p:cNvPicPr>
                    <a:picLocks noChangeAspect="1"/>
                  </p:cNvPicPr>
                  <p:nvPr/>
                </p:nvPicPr>
                <p:blipFill>
                  <a:blip r:embed="rId1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181600" y="2407373"/>
                    <a:ext cx="1901952" cy="152876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59" name="TextBox 58"/>
                <p:cNvSpPr txBox="1"/>
                <p:nvPr/>
              </p:nvSpPr>
              <p:spPr>
                <a:xfrm>
                  <a:off x="5334000" y="2039779"/>
                  <a:ext cx="3810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G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>
                  <a:off x="5887947" y="2039779"/>
                  <a:ext cx="5333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G 1h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6513116" y="2039779"/>
                  <a:ext cx="5333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G 4h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4726781" y="2297431"/>
                  <a:ext cx="5334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4723851" y="2531715"/>
                  <a:ext cx="6858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138" name="Straight Connector 137"/>
            <p:cNvCxnSpPr/>
            <p:nvPr/>
          </p:nvCxnSpPr>
          <p:spPr>
            <a:xfrm>
              <a:off x="5188558" y="2286000"/>
              <a:ext cx="59445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/>
            <p:nvPr/>
          </p:nvCxnSpPr>
          <p:spPr>
            <a:xfrm>
              <a:off x="5833263" y="2286000"/>
              <a:ext cx="6104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6510549" y="2286000"/>
              <a:ext cx="543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8" name="Group 147"/>
          <p:cNvGrpSpPr/>
          <p:nvPr/>
        </p:nvGrpSpPr>
        <p:grpSpPr>
          <a:xfrm>
            <a:off x="5207397" y="4495800"/>
            <a:ext cx="2408298" cy="1059394"/>
            <a:chOff x="4674823" y="3072704"/>
            <a:chExt cx="2408298" cy="1059394"/>
          </a:xfrm>
        </p:grpSpPr>
        <p:grpSp>
          <p:nvGrpSpPr>
            <p:cNvPr id="113" name="Group 112"/>
            <p:cNvGrpSpPr/>
            <p:nvPr/>
          </p:nvGrpSpPr>
          <p:grpSpPr>
            <a:xfrm>
              <a:off x="4674823" y="3072704"/>
              <a:ext cx="2408298" cy="1059394"/>
              <a:chOff x="4674823" y="3072704"/>
              <a:chExt cx="2408298" cy="1059394"/>
            </a:xfrm>
          </p:grpSpPr>
          <p:grpSp>
            <p:nvGrpSpPr>
              <p:cNvPr id="96" name="Group 95"/>
              <p:cNvGrpSpPr/>
              <p:nvPr/>
            </p:nvGrpSpPr>
            <p:grpSpPr>
              <a:xfrm>
                <a:off x="4674823" y="3072704"/>
                <a:ext cx="2369125" cy="902516"/>
                <a:chOff x="4690578" y="2101482"/>
                <a:chExt cx="2369125" cy="902516"/>
              </a:xfrm>
            </p:grpSpPr>
            <p:sp>
              <p:nvSpPr>
                <p:cNvPr id="97" name="TextBox 96"/>
                <p:cNvSpPr txBox="1"/>
                <p:nvPr/>
              </p:nvSpPr>
              <p:spPr>
                <a:xfrm>
                  <a:off x="4742536" y="2439061"/>
                  <a:ext cx="5334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tg7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98" name="Group 97"/>
                <p:cNvGrpSpPr/>
                <p:nvPr/>
              </p:nvGrpSpPr>
              <p:grpSpPr>
                <a:xfrm>
                  <a:off x="4690578" y="2101482"/>
                  <a:ext cx="2369125" cy="902516"/>
                  <a:chOff x="4690578" y="2101482"/>
                  <a:chExt cx="2369125" cy="902516"/>
                </a:xfrm>
              </p:grpSpPr>
              <p:sp>
                <p:nvSpPr>
                  <p:cNvPr id="102" name="TextBox 101"/>
                  <p:cNvSpPr txBox="1"/>
                  <p:nvPr/>
                </p:nvSpPr>
                <p:spPr>
                  <a:xfrm>
                    <a:off x="5346762" y="2101482"/>
                    <a:ext cx="38100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G</a:t>
                    </a:r>
                    <a:endParaRPr 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3" name="TextBox 102"/>
                  <p:cNvSpPr txBox="1"/>
                  <p:nvPr/>
                </p:nvSpPr>
                <p:spPr>
                  <a:xfrm>
                    <a:off x="5903701" y="2101482"/>
                    <a:ext cx="53339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G 1h</a:t>
                    </a:r>
                    <a:endParaRPr 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5" name="TextBox 104"/>
                  <p:cNvSpPr txBox="1"/>
                  <p:nvPr/>
                </p:nvSpPr>
                <p:spPr>
                  <a:xfrm>
                    <a:off x="6526304" y="2101482"/>
                    <a:ext cx="53339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G 4h</a:t>
                    </a:r>
                    <a:endParaRPr 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7" name="TextBox 106"/>
                  <p:cNvSpPr txBox="1"/>
                  <p:nvPr/>
                </p:nvSpPr>
                <p:spPr>
                  <a:xfrm>
                    <a:off x="4690578" y="2773166"/>
                    <a:ext cx="68580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</a:t>
                    </a:r>
                    <a:r>
                      <a:rPr lang="en-US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actin</a:t>
                    </a:r>
                    <a:endParaRPr 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pic>
            <p:nvPicPr>
              <p:cNvPr id="110" name="Picture 109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75549" y="3394763"/>
                <a:ext cx="1901952" cy="301797"/>
              </a:xfrm>
              <a:prstGeom prst="rect">
                <a:avLst/>
              </a:prstGeom>
            </p:spPr>
          </p:pic>
          <p:pic>
            <p:nvPicPr>
              <p:cNvPr id="112" name="Picture 111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81169" y="3696560"/>
                <a:ext cx="1901952" cy="435538"/>
              </a:xfrm>
              <a:prstGeom prst="rect">
                <a:avLst/>
              </a:prstGeom>
            </p:spPr>
          </p:pic>
        </p:grpSp>
        <p:cxnSp>
          <p:nvCxnSpPr>
            <p:cNvPr id="144" name="Straight Connector 143"/>
            <p:cNvCxnSpPr/>
            <p:nvPr/>
          </p:nvCxnSpPr>
          <p:spPr>
            <a:xfrm>
              <a:off x="5197534" y="3319462"/>
              <a:ext cx="59445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/>
            <p:cNvCxnSpPr/>
            <p:nvPr/>
          </p:nvCxnSpPr>
          <p:spPr>
            <a:xfrm>
              <a:off x="5836871" y="3319462"/>
              <a:ext cx="59445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/>
            <p:cNvCxnSpPr/>
            <p:nvPr/>
          </p:nvCxnSpPr>
          <p:spPr>
            <a:xfrm>
              <a:off x="6478725" y="3319462"/>
              <a:ext cx="59445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1" name="TextBox 110"/>
          <p:cNvSpPr txBox="1"/>
          <p:nvPr/>
        </p:nvSpPr>
        <p:spPr>
          <a:xfrm>
            <a:off x="152399" y="0"/>
            <a:ext cx="82296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: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lots to support Figure 5D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576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6</TotalTime>
  <Words>343</Words>
  <Application>Microsoft Office PowerPoint</Application>
  <PresentationFormat>On-screen Show (4:3)</PresentationFormat>
  <Paragraphs>17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er, Amy</dc:creator>
  <cp:lastModifiedBy>Keller, Amy</cp:lastModifiedBy>
  <cp:revision>26</cp:revision>
  <dcterms:created xsi:type="dcterms:W3CDTF">2015-03-20T19:56:35Z</dcterms:created>
  <dcterms:modified xsi:type="dcterms:W3CDTF">2015-09-17T21:54:20Z</dcterms:modified>
</cp:coreProperties>
</file>